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7196138" cy="89979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34">
          <p15:clr>
            <a:srgbClr val="A4A3A4"/>
          </p15:clr>
        </p15:guide>
        <p15:guide id="2" pos="226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2376" autoAdjust="0"/>
    <p:restoredTop sz="99330" autoAdjust="0"/>
  </p:normalViewPr>
  <p:slideViewPr>
    <p:cSldViewPr snapToGrid="0" snapToObjects="1">
      <p:cViewPr>
        <p:scale>
          <a:sx n="150" d="100"/>
          <a:sy n="150" d="100"/>
        </p:scale>
        <p:origin x="2976" y="144"/>
      </p:cViewPr>
      <p:guideLst>
        <p:guide orient="horz" pos="2834"/>
        <p:guide pos="2267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9711" y="2795197"/>
            <a:ext cx="6116717" cy="192872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79421" y="5098838"/>
            <a:ext cx="5037297" cy="229947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95F8B3-46A4-C747-8CFD-B83CD4361348}" type="datetimeFigureOut">
              <a:rPr lang="en-US" smtClean="0"/>
              <a:t>8/1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94A4E-FFAF-384C-BFEE-CD65E3097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63246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95F8B3-46A4-C747-8CFD-B83CD4361348}" type="datetimeFigureOut">
              <a:rPr lang="en-US" smtClean="0"/>
              <a:t>8/1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94A4E-FFAF-384C-BFEE-CD65E3097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42106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106547" y="472810"/>
            <a:ext cx="1273066" cy="1007270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83598" y="472810"/>
            <a:ext cx="3703013" cy="1007270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95F8B3-46A4-C747-8CFD-B83CD4361348}" type="datetimeFigureOut">
              <a:rPr lang="en-US" smtClean="0"/>
              <a:t>8/1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94A4E-FFAF-384C-BFEE-CD65E3097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00142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95F8B3-46A4-C747-8CFD-B83CD4361348}" type="datetimeFigureOut">
              <a:rPr lang="en-US" smtClean="0"/>
              <a:t>8/1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94A4E-FFAF-384C-BFEE-CD65E3097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44882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8445" y="5782017"/>
            <a:ext cx="6116717" cy="178709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8445" y="3813716"/>
            <a:ext cx="6116717" cy="1968301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95F8B3-46A4-C747-8CFD-B83CD4361348}" type="datetimeFigureOut">
              <a:rPr lang="en-US" smtClean="0"/>
              <a:t>8/1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94A4E-FFAF-384C-BFEE-CD65E3097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42805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83598" y="2755623"/>
            <a:ext cx="2487415" cy="778989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890949" y="2755623"/>
            <a:ext cx="2488664" cy="778989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95F8B3-46A4-C747-8CFD-B83CD4361348}" type="datetimeFigureOut">
              <a:rPr lang="en-US" smtClean="0"/>
              <a:t>8/1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94A4E-FFAF-384C-BFEE-CD65E3097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89960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9807" y="360335"/>
            <a:ext cx="6476524" cy="1499658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9807" y="2014125"/>
            <a:ext cx="3179544" cy="83939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9807" y="2853517"/>
            <a:ext cx="3179544" cy="518423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55539" y="2014125"/>
            <a:ext cx="3180793" cy="83939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55539" y="2853517"/>
            <a:ext cx="3180793" cy="518423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95F8B3-46A4-C747-8CFD-B83CD4361348}" type="datetimeFigureOut">
              <a:rPr lang="en-US" smtClean="0"/>
              <a:t>8/11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94A4E-FFAF-384C-BFEE-CD65E3097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4641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95F8B3-46A4-C747-8CFD-B83CD4361348}" type="datetimeFigureOut">
              <a:rPr lang="en-US" smtClean="0"/>
              <a:t>8/11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94A4E-FFAF-384C-BFEE-CD65E3097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74552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95F8B3-46A4-C747-8CFD-B83CD4361348}" type="datetimeFigureOut">
              <a:rPr lang="en-US" smtClean="0"/>
              <a:t>8/11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94A4E-FFAF-384C-BFEE-CD65E3097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39809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9807" y="358252"/>
            <a:ext cx="2367480" cy="1524653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813490" y="358252"/>
            <a:ext cx="4022841" cy="767950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59807" y="1882905"/>
            <a:ext cx="2367480" cy="615484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95F8B3-46A4-C747-8CFD-B83CD4361348}" type="datetimeFigureOut">
              <a:rPr lang="en-US" smtClean="0"/>
              <a:t>8/1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94A4E-FFAF-384C-BFEE-CD65E3097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74126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10493" y="6298565"/>
            <a:ext cx="4317683" cy="74358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410493" y="803983"/>
            <a:ext cx="4317683" cy="539877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10493" y="7042146"/>
            <a:ext cx="4317683" cy="105600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95F8B3-46A4-C747-8CFD-B83CD4361348}" type="datetimeFigureOut">
              <a:rPr lang="en-US" smtClean="0"/>
              <a:t>8/1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94A4E-FFAF-384C-BFEE-CD65E3097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76308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59807" y="360335"/>
            <a:ext cx="6476524" cy="149965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9807" y="2099522"/>
            <a:ext cx="6476524" cy="593823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59807" y="8339767"/>
            <a:ext cx="1679099" cy="47905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95F8B3-46A4-C747-8CFD-B83CD4361348}" type="datetimeFigureOut">
              <a:rPr lang="en-US" smtClean="0"/>
              <a:t>8/1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58681" y="8339767"/>
            <a:ext cx="2278777" cy="47905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57232" y="8339767"/>
            <a:ext cx="1679099" cy="47905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494A4E-FFAF-384C-BFEE-CD65E3097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4022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5" Type="http://schemas.openxmlformats.org/officeDocument/2006/relationships/image" Target="../media/image4.em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95392" y="910703"/>
            <a:ext cx="274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A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5" name="TextBox 4"/>
          <p:cNvSpPr txBox="1"/>
          <p:nvPr/>
        </p:nvSpPr>
        <p:spPr>
          <a:xfrm rot="16200000">
            <a:off x="-620029" y="2130962"/>
            <a:ext cx="21218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Average number of eggs laid normalized to unexposed</a:t>
            </a:r>
            <a:endParaRPr lang="en-US" sz="1200" dirty="0">
              <a:latin typeface="Times New Roman"/>
              <a:cs typeface="Times New Roman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81069" t="48135" b="46715"/>
          <a:stretch/>
        </p:blipFill>
        <p:spPr>
          <a:xfrm>
            <a:off x="2446618" y="3662777"/>
            <a:ext cx="1246313" cy="253973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81069" t="53972" r="496" b="40795"/>
          <a:stretch/>
        </p:blipFill>
        <p:spPr>
          <a:xfrm>
            <a:off x="3599218" y="3700961"/>
            <a:ext cx="1213633" cy="258118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845327" y="956869"/>
            <a:ext cx="28073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i="1" dirty="0" err="1" smtClean="0">
                <a:latin typeface="Times New Roman"/>
                <a:cs typeface="Times New Roman"/>
              </a:rPr>
              <a:t>Gug</a:t>
            </a:r>
            <a:r>
              <a:rPr lang="en-US" sz="1200" baseline="30000" dirty="0" err="1" smtClean="0">
                <a:latin typeface="Times New Roman"/>
                <a:cs typeface="Times New Roman"/>
              </a:rPr>
              <a:t>RNAi</a:t>
            </a:r>
            <a:r>
              <a:rPr lang="en-US" sz="1200" dirty="0" smtClean="0">
                <a:latin typeface="Times New Roman"/>
                <a:cs typeface="Times New Roman"/>
              </a:rPr>
              <a:t>/+ flies show memory retention</a:t>
            </a:r>
            <a:endParaRPr lang="en-US" sz="1200" i="1" dirty="0">
              <a:latin typeface="Times New Roman"/>
              <a:cs typeface="Times New Roman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683351" y="910703"/>
            <a:ext cx="274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B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206035" y="956869"/>
            <a:ext cx="26058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Times New Roman"/>
                <a:cs typeface="Times New Roman"/>
              </a:rPr>
              <a:t>HRPF </a:t>
            </a:r>
            <a:r>
              <a:rPr lang="en-US" sz="1200" dirty="0" smtClean="0">
                <a:latin typeface="Times New Roman"/>
                <a:cs typeface="Times New Roman"/>
              </a:rPr>
              <a:t>flies show memory retention</a:t>
            </a:r>
            <a:endParaRPr lang="en-US" sz="1200" i="1" dirty="0">
              <a:latin typeface="Times New Roman"/>
              <a:cs typeface="Times New Roman"/>
            </a:endParaRP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70411" y="1319623"/>
            <a:ext cx="2802541" cy="2103120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1249818" y="2589751"/>
            <a:ext cx="274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*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884783" y="2742151"/>
            <a:ext cx="274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*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519748" y="2756051"/>
            <a:ext cx="274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*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154713" y="2769951"/>
            <a:ext cx="274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*</a:t>
            </a:r>
            <a:endParaRPr lang="en-US" sz="1200" dirty="0">
              <a:latin typeface="Times New Roman"/>
              <a:cs typeface="Times New Roman"/>
            </a:endParaRPr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095976" y="1319623"/>
            <a:ext cx="2807398" cy="2103120"/>
          </a:xfrm>
          <a:prstGeom prst="rect">
            <a:avLst/>
          </a:prstGeom>
        </p:spPr>
      </p:pic>
      <p:sp>
        <p:nvSpPr>
          <p:cNvPr id="18" name="TextBox 17"/>
          <p:cNvSpPr txBox="1"/>
          <p:nvPr/>
        </p:nvSpPr>
        <p:spPr>
          <a:xfrm>
            <a:off x="4580888" y="2886083"/>
            <a:ext cx="274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*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5207386" y="2719783"/>
            <a:ext cx="274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*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5842351" y="2631451"/>
            <a:ext cx="274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*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6477315" y="2523786"/>
            <a:ext cx="274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*</a:t>
            </a:r>
            <a:endParaRPr lang="en-US" sz="12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8462510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7</TotalTime>
  <Words>29</Words>
  <Application>Microsoft Macintosh PowerPoint</Application>
  <PresentationFormat>Custom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Times New Roman</vt:lpstr>
      <vt:lpstr>Arial</vt:lpstr>
      <vt:lpstr>Office Theme</vt:lpstr>
      <vt:lpstr>PowerPoint Presentation</vt:lpstr>
    </vt:vector>
  </TitlesOfParts>
  <Company>Home</Company>
  <LinksUpToDate>false</LinksUpToDate>
  <SharedDoc>false</SharedDoc>
  <HyperlinksChanged>false</HyperlinksChanged>
  <AppVersion>15.003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lint Kacsoh</dc:creator>
  <cp:lastModifiedBy>Balint Kacsoh</cp:lastModifiedBy>
  <cp:revision>6</cp:revision>
  <dcterms:created xsi:type="dcterms:W3CDTF">2017-06-06T18:17:03Z</dcterms:created>
  <dcterms:modified xsi:type="dcterms:W3CDTF">2017-08-11T20:24:14Z</dcterms:modified>
</cp:coreProperties>
</file>